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588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952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788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281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355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900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058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64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769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136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214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277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374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wang426\Desktop\S5-1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943355"/>
            <a:ext cx="1828800" cy="49885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wang426\Desktop\S5-2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0" y="973976"/>
            <a:ext cx="1828800" cy="49885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wang426\Desktop\S5-3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9800" y="987002"/>
            <a:ext cx="1828800" cy="49754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 rot="16200000">
            <a:off x="-491313" y="3185169"/>
            <a:ext cx="3356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eavy                                      Light</a:t>
            </a:r>
            <a:endParaRPr lang="en-US" b="1" dirty="0"/>
          </a:p>
        </p:txBody>
      </p:sp>
      <p:sp>
        <p:nvSpPr>
          <p:cNvPr id="11" name="Rectangle 10"/>
          <p:cNvSpPr/>
          <p:nvPr/>
        </p:nvSpPr>
        <p:spPr>
          <a:xfrm>
            <a:off x="1447800" y="685800"/>
            <a:ext cx="662940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srgbClr val="000000"/>
                </a:solidFill>
                <a:ea typeface="Times New Roman"/>
                <a:cs typeface="Arial"/>
              </a:rPr>
              <a:t>VNPKGLDEESKDYLSLYLLLVSCPKSEVR    AKFKFSILNAKGEETKAMESQR</a:t>
            </a:r>
            <a:r>
              <a:rPr lang="en-US" sz="1200" b="1" dirty="0" smtClean="0"/>
              <a:t>         </a:t>
            </a:r>
            <a:r>
              <a:rPr lang="en-US" sz="1200" b="1" dirty="0" err="1" smtClean="0">
                <a:solidFill>
                  <a:srgbClr val="000000"/>
                </a:solidFill>
                <a:ea typeface="Times New Roman"/>
                <a:cs typeface="Arial"/>
              </a:rPr>
              <a:t>AKFKFSILNAKGEETKAMESQR</a:t>
            </a:r>
            <a:endParaRPr lang="en-US" sz="1200" b="1" dirty="0" smtClean="0"/>
          </a:p>
          <a:p>
            <a:endParaRPr lang="en-US" sz="10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303377" y="5886283"/>
            <a:ext cx="5181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WT                                     </a:t>
            </a:r>
            <a:r>
              <a:rPr lang="en-US" b="1" dirty="0" err="1" smtClean="0"/>
              <a:t>WT</a:t>
            </a:r>
            <a:r>
              <a:rPr lang="en-US" b="1" dirty="0" smtClean="0"/>
              <a:t>                                  F133V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743200" y="1009483"/>
            <a:ext cx="502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.D.		        N.D.		               N.D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73637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73</TotalTime>
  <Words>1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PNN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uantification of Mutant SPOP Proteins in Prostate Cancer Using Mass Spectrometry-Based Targeted Proteomics</dc:title>
  <dc:creator>test</dc:creator>
  <cp:lastModifiedBy>Liu, Tao</cp:lastModifiedBy>
  <cp:revision>19</cp:revision>
  <dcterms:created xsi:type="dcterms:W3CDTF">2017-05-12T18:52:21Z</dcterms:created>
  <dcterms:modified xsi:type="dcterms:W3CDTF">2017-07-15T07:30:56Z</dcterms:modified>
</cp:coreProperties>
</file>